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330" r:id="rId5"/>
    <p:sldId id="334" r:id="rId6"/>
  </p:sldIdLst>
  <p:sldSz cx="12192000" cy="6858000"/>
  <p:notesSz cx="6858000" cy="9144000"/>
  <p:defaultTextStyle>
    <a:defPPr>
      <a:defRPr lang="zh-H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Age Prevalence analysis (12010 group) 20220707.xlsx]4 groups'!$A$11</c:f>
              <c:strCache>
                <c:ptCount val="1"/>
                <c:pt idx="0">
                  <c:v>&lt;18 (n=860)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[Age Prevalence analysis (12010 group) 20220707.xlsx]4 groups'!$B$10:$P$10</c:f>
              <c:strCache>
                <c:ptCount val="15"/>
                <c:pt idx="0">
                  <c:v>Cough</c:v>
                </c:pt>
                <c:pt idx="1">
                  <c:v>Sputum*</c:v>
                </c:pt>
                <c:pt idx="2">
                  <c:v>Dry throat*</c:v>
                </c:pt>
                <c:pt idx="3">
                  <c:v>Itchy throat*</c:v>
                </c:pt>
                <c:pt idx="4">
                  <c:v>Sore throat*</c:v>
                </c:pt>
                <c:pt idx="5">
                  <c:v>Chest tightness*</c:v>
                </c:pt>
                <c:pt idx="6">
                  <c:v>Diarrhea</c:v>
                </c:pt>
                <c:pt idx="7">
                  <c:v>Abdominal distension</c:v>
                </c:pt>
                <c:pt idx="8">
                  <c:v>Abdominal pain</c:v>
                </c:pt>
                <c:pt idx="9">
                  <c:v>Nausea</c:v>
                </c:pt>
                <c:pt idx="10">
                  <c:v>Fatigue*</c:v>
                </c:pt>
                <c:pt idx="11">
                  <c:v>Headache*</c:v>
                </c:pt>
                <c:pt idx="12">
                  <c:v>Muscle pain*</c:v>
                </c:pt>
                <c:pt idx="13">
                  <c:v>Fever</c:v>
                </c:pt>
                <c:pt idx="14">
                  <c:v>Chill*</c:v>
                </c:pt>
              </c:strCache>
            </c:strRef>
          </c:cat>
          <c:val>
            <c:numRef>
              <c:f>'[Age Prevalence analysis (12010 group) 20220707.xlsx]4 groups'!$B$11:$P$11</c:f>
              <c:numCache>
                <c:formatCode>###0.0%</c:formatCode>
                <c:ptCount val="15"/>
                <c:pt idx="0">
                  <c:v>0.8418604651162791</c:v>
                </c:pt>
                <c:pt idx="1">
                  <c:v>0.51860465116279075</c:v>
                </c:pt>
                <c:pt idx="2">
                  <c:v>0.28488372093023256</c:v>
                </c:pt>
                <c:pt idx="3">
                  <c:v>0.1674418604651163</c:v>
                </c:pt>
                <c:pt idx="4">
                  <c:v>0.2069767441860465</c:v>
                </c:pt>
                <c:pt idx="5">
                  <c:v>2.5581395348837209E-2</c:v>
                </c:pt>
                <c:pt idx="6">
                  <c:v>0.14651162790697675</c:v>
                </c:pt>
                <c:pt idx="7">
                  <c:v>0.13023255813953488</c:v>
                </c:pt>
                <c:pt idx="8">
                  <c:v>6.2790697674418611E-2</c:v>
                </c:pt>
                <c:pt idx="9">
                  <c:v>3.7209302325581395E-2</c:v>
                </c:pt>
                <c:pt idx="10">
                  <c:v>0.21976744186046512</c:v>
                </c:pt>
                <c:pt idx="11">
                  <c:v>6.6279069767441856E-2</c:v>
                </c:pt>
                <c:pt idx="12">
                  <c:v>5.232558139534884E-2</c:v>
                </c:pt>
                <c:pt idx="13">
                  <c:v>4.3023255813953491E-2</c:v>
                </c:pt>
                <c:pt idx="14">
                  <c:v>2.209302325581395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FF-49B5-B016-EBCEF1286C7F}"/>
            </c:ext>
          </c:extLst>
        </c:ser>
        <c:ser>
          <c:idx val="1"/>
          <c:order val="1"/>
          <c:tx>
            <c:strRef>
              <c:f>'[Age Prevalence analysis (12010 group) 20220707.xlsx]4 groups'!$A$12</c:f>
              <c:strCache>
                <c:ptCount val="1"/>
                <c:pt idx="0">
                  <c:v>18~64 (n=8827)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[Age Prevalence analysis (12010 group) 20220707.xlsx]4 groups'!$B$10:$P$10</c:f>
              <c:strCache>
                <c:ptCount val="15"/>
                <c:pt idx="0">
                  <c:v>Cough</c:v>
                </c:pt>
                <c:pt idx="1">
                  <c:v>Sputum*</c:v>
                </c:pt>
                <c:pt idx="2">
                  <c:v>Dry throat*</c:v>
                </c:pt>
                <c:pt idx="3">
                  <c:v>Itchy throat*</c:v>
                </c:pt>
                <c:pt idx="4">
                  <c:v>Sore throat*</c:v>
                </c:pt>
                <c:pt idx="5">
                  <c:v>Chest tightness*</c:v>
                </c:pt>
                <c:pt idx="6">
                  <c:v>Diarrhea</c:v>
                </c:pt>
                <c:pt idx="7">
                  <c:v>Abdominal distension</c:v>
                </c:pt>
                <c:pt idx="8">
                  <c:v>Abdominal pain</c:v>
                </c:pt>
                <c:pt idx="9">
                  <c:v>Nausea</c:v>
                </c:pt>
                <c:pt idx="10">
                  <c:v>Fatigue*</c:v>
                </c:pt>
                <c:pt idx="11">
                  <c:v>Headache*</c:v>
                </c:pt>
                <c:pt idx="12">
                  <c:v>Muscle pain*</c:v>
                </c:pt>
                <c:pt idx="13">
                  <c:v>Fever</c:v>
                </c:pt>
                <c:pt idx="14">
                  <c:v>Chill*</c:v>
                </c:pt>
              </c:strCache>
            </c:strRef>
          </c:cat>
          <c:val>
            <c:numRef>
              <c:f>'[Age Prevalence analysis (12010 group) 20220707.xlsx]4 groups'!$B$12:$P$12</c:f>
              <c:numCache>
                <c:formatCode>###0.0%</c:formatCode>
                <c:ptCount val="15"/>
                <c:pt idx="0">
                  <c:v>0.84184887277670784</c:v>
                </c:pt>
                <c:pt idx="1">
                  <c:v>0.64619916166307911</c:v>
                </c:pt>
                <c:pt idx="2">
                  <c:v>0.47558626940070231</c:v>
                </c:pt>
                <c:pt idx="3">
                  <c:v>0.36082474226804123</c:v>
                </c:pt>
                <c:pt idx="4">
                  <c:v>0.26860768097881499</c:v>
                </c:pt>
                <c:pt idx="5">
                  <c:v>0.12371134020618557</c:v>
                </c:pt>
                <c:pt idx="6">
                  <c:v>0.17842981760507534</c:v>
                </c:pt>
                <c:pt idx="7">
                  <c:v>0.11838676787130394</c:v>
                </c:pt>
                <c:pt idx="8">
                  <c:v>4.6221819417695709E-2</c:v>
                </c:pt>
                <c:pt idx="9">
                  <c:v>3.6252407386428008E-2</c:v>
                </c:pt>
                <c:pt idx="10">
                  <c:v>0.36750877987991393</c:v>
                </c:pt>
                <c:pt idx="11">
                  <c:v>0.18726634190551716</c:v>
                </c:pt>
                <c:pt idx="12">
                  <c:v>0.16166307918885237</c:v>
                </c:pt>
                <c:pt idx="13">
                  <c:v>4.4409199048374308E-2</c:v>
                </c:pt>
                <c:pt idx="14">
                  <c:v>4.45224878214568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3FF-49B5-B016-EBCEF1286C7F}"/>
            </c:ext>
          </c:extLst>
        </c:ser>
        <c:ser>
          <c:idx val="2"/>
          <c:order val="2"/>
          <c:tx>
            <c:strRef>
              <c:f>'[Age Prevalence analysis (12010 group) 20220707.xlsx]4 groups'!$A$13</c:f>
              <c:strCache>
                <c:ptCount val="1"/>
                <c:pt idx="0">
                  <c:v>65~80 (n=1801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[Age Prevalence analysis (12010 group) 20220707.xlsx]4 groups'!$B$10:$P$10</c:f>
              <c:strCache>
                <c:ptCount val="15"/>
                <c:pt idx="0">
                  <c:v>Cough</c:v>
                </c:pt>
                <c:pt idx="1">
                  <c:v>Sputum*</c:v>
                </c:pt>
                <c:pt idx="2">
                  <c:v>Dry throat*</c:v>
                </c:pt>
                <c:pt idx="3">
                  <c:v>Itchy throat*</c:v>
                </c:pt>
                <c:pt idx="4">
                  <c:v>Sore throat*</c:v>
                </c:pt>
                <c:pt idx="5">
                  <c:v>Chest tightness*</c:v>
                </c:pt>
                <c:pt idx="6">
                  <c:v>Diarrhea</c:v>
                </c:pt>
                <c:pt idx="7">
                  <c:v>Abdominal distension</c:v>
                </c:pt>
                <c:pt idx="8">
                  <c:v>Abdominal pain</c:v>
                </c:pt>
                <c:pt idx="9">
                  <c:v>Nausea</c:v>
                </c:pt>
                <c:pt idx="10">
                  <c:v>Fatigue*</c:v>
                </c:pt>
                <c:pt idx="11">
                  <c:v>Headache*</c:v>
                </c:pt>
                <c:pt idx="12">
                  <c:v>Muscle pain*</c:v>
                </c:pt>
                <c:pt idx="13">
                  <c:v>Fever</c:v>
                </c:pt>
                <c:pt idx="14">
                  <c:v>Chill*</c:v>
                </c:pt>
              </c:strCache>
            </c:strRef>
          </c:cat>
          <c:val>
            <c:numRef>
              <c:f>'[Age Prevalence analysis (12010 group) 20220707.xlsx]4 groups'!$B$13:$P$13</c:f>
              <c:numCache>
                <c:formatCode>###0.0%</c:formatCode>
                <c:ptCount val="15"/>
                <c:pt idx="0">
                  <c:v>0.84564131038312051</c:v>
                </c:pt>
                <c:pt idx="1">
                  <c:v>0.69961132704053308</c:v>
                </c:pt>
                <c:pt idx="2">
                  <c:v>0.47251526929483623</c:v>
                </c:pt>
                <c:pt idx="3">
                  <c:v>0.29872293170460856</c:v>
                </c:pt>
                <c:pt idx="4">
                  <c:v>0.20044419766796223</c:v>
                </c:pt>
                <c:pt idx="5">
                  <c:v>0.12215435868961688</c:v>
                </c:pt>
                <c:pt idx="6">
                  <c:v>0.16935036091060521</c:v>
                </c:pt>
                <c:pt idx="7">
                  <c:v>0.12215435868961688</c:v>
                </c:pt>
                <c:pt idx="8">
                  <c:v>4.3309272626318715E-2</c:v>
                </c:pt>
                <c:pt idx="9">
                  <c:v>4.2198778456413101E-2</c:v>
                </c:pt>
                <c:pt idx="10">
                  <c:v>0.39478067740144362</c:v>
                </c:pt>
                <c:pt idx="11">
                  <c:v>0.16935036091060521</c:v>
                </c:pt>
                <c:pt idx="12">
                  <c:v>0.13603553581343697</c:v>
                </c:pt>
                <c:pt idx="13">
                  <c:v>3.886729594669628E-2</c:v>
                </c:pt>
                <c:pt idx="14">
                  <c:v>4.997223764575235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3FF-49B5-B016-EBCEF1286C7F}"/>
            </c:ext>
          </c:extLst>
        </c:ser>
        <c:ser>
          <c:idx val="3"/>
          <c:order val="3"/>
          <c:tx>
            <c:strRef>
              <c:f>'[Age Prevalence analysis (12010 group) 20220707.xlsx]4 groups'!$A$14</c:f>
              <c:strCache>
                <c:ptCount val="1"/>
                <c:pt idx="0">
                  <c:v>&gt;80 (n=522)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[Age Prevalence analysis (12010 group) 20220707.xlsx]4 groups'!$B$10:$P$10</c:f>
              <c:strCache>
                <c:ptCount val="15"/>
                <c:pt idx="0">
                  <c:v>Cough</c:v>
                </c:pt>
                <c:pt idx="1">
                  <c:v>Sputum*</c:v>
                </c:pt>
                <c:pt idx="2">
                  <c:v>Dry throat*</c:v>
                </c:pt>
                <c:pt idx="3">
                  <c:v>Itchy throat*</c:v>
                </c:pt>
                <c:pt idx="4">
                  <c:v>Sore throat*</c:v>
                </c:pt>
                <c:pt idx="5">
                  <c:v>Chest tightness*</c:v>
                </c:pt>
                <c:pt idx="6">
                  <c:v>Diarrhea</c:v>
                </c:pt>
                <c:pt idx="7">
                  <c:v>Abdominal distension</c:v>
                </c:pt>
                <c:pt idx="8">
                  <c:v>Abdominal pain</c:v>
                </c:pt>
                <c:pt idx="9">
                  <c:v>Nausea</c:v>
                </c:pt>
                <c:pt idx="10">
                  <c:v>Fatigue*</c:v>
                </c:pt>
                <c:pt idx="11">
                  <c:v>Headache*</c:v>
                </c:pt>
                <c:pt idx="12">
                  <c:v>Muscle pain*</c:v>
                </c:pt>
                <c:pt idx="13">
                  <c:v>Fever</c:v>
                </c:pt>
                <c:pt idx="14">
                  <c:v>Chill*</c:v>
                </c:pt>
              </c:strCache>
            </c:strRef>
          </c:cat>
          <c:val>
            <c:numRef>
              <c:f>'[Age Prevalence analysis (12010 group) 20220707.xlsx]4 groups'!$B$14:$P$14</c:f>
              <c:numCache>
                <c:formatCode>###0.0%</c:formatCode>
                <c:ptCount val="15"/>
                <c:pt idx="0">
                  <c:v>0.88314176245210729</c:v>
                </c:pt>
                <c:pt idx="1">
                  <c:v>0.74329501915708818</c:v>
                </c:pt>
                <c:pt idx="2">
                  <c:v>0.37356321839080459</c:v>
                </c:pt>
                <c:pt idx="3">
                  <c:v>0.19923371647509577</c:v>
                </c:pt>
                <c:pt idx="4">
                  <c:v>0.1532567049808429</c:v>
                </c:pt>
                <c:pt idx="5">
                  <c:v>0.13026819923371646</c:v>
                </c:pt>
                <c:pt idx="6">
                  <c:v>0.17049808429118773</c:v>
                </c:pt>
                <c:pt idx="7">
                  <c:v>0.14559386973180077</c:v>
                </c:pt>
                <c:pt idx="8">
                  <c:v>5.938697318007663E-2</c:v>
                </c:pt>
                <c:pt idx="9">
                  <c:v>4.2145593869731802E-2</c:v>
                </c:pt>
                <c:pt idx="10">
                  <c:v>0.44636015325670497</c:v>
                </c:pt>
                <c:pt idx="11">
                  <c:v>9.9616858237547887E-2</c:v>
                </c:pt>
                <c:pt idx="12">
                  <c:v>0.13218390804597702</c:v>
                </c:pt>
                <c:pt idx="13">
                  <c:v>4.5977011494252873E-2</c:v>
                </c:pt>
                <c:pt idx="14">
                  <c:v>3.831417624521072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3FF-49B5-B016-EBCEF1286C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39488032"/>
        <c:axId val="839488360"/>
      </c:barChart>
      <c:catAx>
        <c:axId val="839488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HK"/>
          </a:p>
        </c:txPr>
        <c:crossAx val="839488360"/>
        <c:crosses val="autoZero"/>
        <c:auto val="1"/>
        <c:lblAlgn val="ctr"/>
        <c:lblOffset val="100"/>
        <c:noMultiLvlLbl val="0"/>
      </c:catAx>
      <c:valAx>
        <c:axId val="8394883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HK"/>
          </a:p>
        </c:txPr>
        <c:crossAx val="8394880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HK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HK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ender!$A$3</c:f>
              <c:strCache>
                <c:ptCount val="1"/>
                <c:pt idx="0">
                  <c:v>Female (n=8190)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der!$B$1:$P$1</c:f>
              <c:strCache>
                <c:ptCount val="15"/>
                <c:pt idx="0">
                  <c:v>Cough*</c:v>
                </c:pt>
                <c:pt idx="1">
                  <c:v>Sputum</c:v>
                </c:pt>
                <c:pt idx="2">
                  <c:v>Dry throat*</c:v>
                </c:pt>
                <c:pt idx="3">
                  <c:v>Itchy throat</c:v>
                </c:pt>
                <c:pt idx="4">
                  <c:v>Sore throat*</c:v>
                </c:pt>
                <c:pt idx="5">
                  <c:v>Chest tightness*</c:v>
                </c:pt>
                <c:pt idx="6">
                  <c:v>Diarrhea</c:v>
                </c:pt>
                <c:pt idx="7">
                  <c:v>Abdominal distension*</c:v>
                </c:pt>
                <c:pt idx="8">
                  <c:v>Abdominal pain*</c:v>
                </c:pt>
                <c:pt idx="9">
                  <c:v>Nausea*</c:v>
                </c:pt>
                <c:pt idx="10">
                  <c:v>Fatigue*</c:v>
                </c:pt>
                <c:pt idx="11">
                  <c:v>Headache*</c:v>
                </c:pt>
                <c:pt idx="12">
                  <c:v>Muscle pain*</c:v>
                </c:pt>
                <c:pt idx="13">
                  <c:v>Fever</c:v>
                </c:pt>
                <c:pt idx="14">
                  <c:v>Chill</c:v>
                </c:pt>
              </c:strCache>
            </c:strRef>
          </c:cat>
          <c:val>
            <c:numRef>
              <c:f>gender!$B$3:$P$3</c:f>
              <c:numCache>
                <c:formatCode>###0.0%</c:formatCode>
                <c:ptCount val="15"/>
                <c:pt idx="0">
                  <c:v>0.83565323565323568</c:v>
                </c:pt>
                <c:pt idx="1">
                  <c:v>0.65103785103785095</c:v>
                </c:pt>
                <c:pt idx="2">
                  <c:v>0.47118437118437112</c:v>
                </c:pt>
                <c:pt idx="3">
                  <c:v>0.33577533577533569</c:v>
                </c:pt>
                <c:pt idx="4">
                  <c:v>0.24249084249084249</c:v>
                </c:pt>
                <c:pt idx="5">
                  <c:v>0.12808302808302807</c:v>
                </c:pt>
                <c:pt idx="6">
                  <c:v>0.17777777777777778</c:v>
                </c:pt>
                <c:pt idx="7">
                  <c:v>0.1354090354090354</c:v>
                </c:pt>
                <c:pt idx="8">
                  <c:v>5.0427350427350429E-2</c:v>
                </c:pt>
                <c:pt idx="9">
                  <c:v>4.2490842490842493E-2</c:v>
                </c:pt>
                <c:pt idx="10">
                  <c:v>0.37704517704517704</c:v>
                </c:pt>
                <c:pt idx="11">
                  <c:v>0.19499389499389502</c:v>
                </c:pt>
                <c:pt idx="12">
                  <c:v>0.16117216117216115</c:v>
                </c:pt>
                <c:pt idx="13">
                  <c:v>4.2979242979242979E-2</c:v>
                </c:pt>
                <c:pt idx="14">
                  <c:v>4.261294261294261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95B-40E0-AB9C-E21830A1D483}"/>
            </c:ext>
          </c:extLst>
        </c:ser>
        <c:ser>
          <c:idx val="1"/>
          <c:order val="1"/>
          <c:tx>
            <c:strRef>
              <c:f>gender!$A$5</c:f>
              <c:strCache>
                <c:ptCount val="1"/>
                <c:pt idx="0">
                  <c:v>Male (n=3820)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gender!$B$1:$P$1</c:f>
              <c:strCache>
                <c:ptCount val="15"/>
                <c:pt idx="0">
                  <c:v>Cough*</c:v>
                </c:pt>
                <c:pt idx="1">
                  <c:v>Sputum</c:v>
                </c:pt>
                <c:pt idx="2">
                  <c:v>Dry throat*</c:v>
                </c:pt>
                <c:pt idx="3">
                  <c:v>Itchy throat</c:v>
                </c:pt>
                <c:pt idx="4">
                  <c:v>Sore throat*</c:v>
                </c:pt>
                <c:pt idx="5">
                  <c:v>Chest tightness*</c:v>
                </c:pt>
                <c:pt idx="6">
                  <c:v>Diarrhea</c:v>
                </c:pt>
                <c:pt idx="7">
                  <c:v>Abdominal distension*</c:v>
                </c:pt>
                <c:pt idx="8">
                  <c:v>Abdominal pain*</c:v>
                </c:pt>
                <c:pt idx="9">
                  <c:v>Nausea*</c:v>
                </c:pt>
                <c:pt idx="10">
                  <c:v>Fatigue*</c:v>
                </c:pt>
                <c:pt idx="11">
                  <c:v>Headache*</c:v>
                </c:pt>
                <c:pt idx="12">
                  <c:v>Muscle pain*</c:v>
                </c:pt>
                <c:pt idx="13">
                  <c:v>Fever</c:v>
                </c:pt>
                <c:pt idx="14">
                  <c:v>Chill</c:v>
                </c:pt>
              </c:strCache>
            </c:strRef>
          </c:cat>
          <c:val>
            <c:numRef>
              <c:f>gender!$B$5:$P$5</c:f>
              <c:numCache>
                <c:formatCode>###0.0%</c:formatCode>
                <c:ptCount val="15"/>
                <c:pt idx="0">
                  <c:v>0.86256544502617805</c:v>
                </c:pt>
                <c:pt idx="1">
                  <c:v>0.64554973821989525</c:v>
                </c:pt>
                <c:pt idx="2">
                  <c:v>0.42670157068062831</c:v>
                </c:pt>
                <c:pt idx="3">
                  <c:v>0.31963350785340316</c:v>
                </c:pt>
                <c:pt idx="4">
                  <c:v>0.26282722513089007</c:v>
                </c:pt>
                <c:pt idx="5">
                  <c:v>9.2408376963350788E-2</c:v>
                </c:pt>
                <c:pt idx="6">
                  <c:v>0.16727748691099475</c:v>
                </c:pt>
                <c:pt idx="7">
                  <c:v>9.0052356020942415E-2</c:v>
                </c:pt>
                <c:pt idx="8">
                  <c:v>4.1361256544502616E-2</c:v>
                </c:pt>
                <c:pt idx="9">
                  <c:v>2.6701570680628273E-2</c:v>
                </c:pt>
                <c:pt idx="10">
                  <c:v>0.33743455497382191</c:v>
                </c:pt>
                <c:pt idx="11">
                  <c:v>0.12303664921465969</c:v>
                </c:pt>
                <c:pt idx="12">
                  <c:v>0.12198952879581151</c:v>
                </c:pt>
                <c:pt idx="13">
                  <c:v>4.476439790575916E-2</c:v>
                </c:pt>
                <c:pt idx="14">
                  <c:v>4.528795811518324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95B-40E0-AB9C-E21830A1D4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1789472"/>
        <c:axId val="911787832"/>
      </c:barChart>
      <c:catAx>
        <c:axId val="911789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HK"/>
          </a:p>
        </c:txPr>
        <c:crossAx val="911787832"/>
        <c:crosses val="autoZero"/>
        <c:auto val="1"/>
        <c:lblAlgn val="ctr"/>
        <c:lblOffset val="100"/>
        <c:noMultiLvlLbl val="0"/>
      </c:catAx>
      <c:valAx>
        <c:axId val="911787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HK"/>
          </a:p>
        </c:txPr>
        <c:crossAx val="9117894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HK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HK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11</c:f>
              <c:strCache>
                <c:ptCount val="1"/>
                <c:pt idx="0">
                  <c:v>Incomplete vaccination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0:$P$10</c:f>
              <c:strCache>
                <c:ptCount val="15"/>
                <c:pt idx="0">
                  <c:v>Cough*</c:v>
                </c:pt>
                <c:pt idx="1">
                  <c:v>Sputum</c:v>
                </c:pt>
                <c:pt idx="2">
                  <c:v>Dry throat*</c:v>
                </c:pt>
                <c:pt idx="3">
                  <c:v>Itchy throat*</c:v>
                </c:pt>
                <c:pt idx="4">
                  <c:v>Sore throat</c:v>
                </c:pt>
                <c:pt idx="5">
                  <c:v>Chest thightness</c:v>
                </c:pt>
                <c:pt idx="6">
                  <c:v>Diarrhea</c:v>
                </c:pt>
                <c:pt idx="7">
                  <c:v>Abdominal distension*</c:v>
                </c:pt>
                <c:pt idx="8">
                  <c:v>Abdominal pain*</c:v>
                </c:pt>
                <c:pt idx="9">
                  <c:v>Nausea*</c:v>
                </c:pt>
                <c:pt idx="10">
                  <c:v>Fatigue</c:v>
                </c:pt>
                <c:pt idx="11">
                  <c:v>Headache</c:v>
                </c:pt>
                <c:pt idx="12">
                  <c:v>Muscle pain</c:v>
                </c:pt>
                <c:pt idx="13">
                  <c:v>Fever*</c:v>
                </c:pt>
                <c:pt idx="14">
                  <c:v>Chill*</c:v>
                </c:pt>
              </c:strCache>
            </c:strRef>
          </c:cat>
          <c:val>
            <c:numRef>
              <c:f>Sheet2!$B$11:$P$11</c:f>
              <c:numCache>
                <c:formatCode>###0.0%</c:formatCode>
                <c:ptCount val="15"/>
                <c:pt idx="0">
                  <c:v>0.85467434647762519</c:v>
                </c:pt>
                <c:pt idx="1">
                  <c:v>0.65906070004430661</c:v>
                </c:pt>
                <c:pt idx="2">
                  <c:v>0.44528134692069116</c:v>
                </c:pt>
                <c:pt idx="3">
                  <c:v>0.30084182543198934</c:v>
                </c:pt>
                <c:pt idx="4">
                  <c:v>0.25431989366415597</c:v>
                </c:pt>
                <c:pt idx="5">
                  <c:v>0.11896322552060257</c:v>
                </c:pt>
                <c:pt idx="6">
                  <c:v>0.20336730172795747</c:v>
                </c:pt>
                <c:pt idx="7">
                  <c:v>0.14731945059813911</c:v>
                </c:pt>
                <c:pt idx="8">
                  <c:v>6.4244572441293751E-2</c:v>
                </c:pt>
                <c:pt idx="9">
                  <c:v>5.1617190961453258E-2</c:v>
                </c:pt>
                <c:pt idx="10">
                  <c:v>0.35445281346920693</c:v>
                </c:pt>
                <c:pt idx="11">
                  <c:v>0.17700487372618523</c:v>
                </c:pt>
                <c:pt idx="12">
                  <c:v>0.14133805937084626</c:v>
                </c:pt>
                <c:pt idx="13">
                  <c:v>5.7598582188746118E-2</c:v>
                </c:pt>
                <c:pt idx="14">
                  <c:v>6.225077536552945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DD-4D09-B16D-005501B6515E}"/>
            </c:ext>
          </c:extLst>
        </c:ser>
        <c:ser>
          <c:idx val="1"/>
          <c:order val="1"/>
          <c:tx>
            <c:strRef>
              <c:f>Sheet2!$A$12</c:f>
              <c:strCache>
                <c:ptCount val="1"/>
                <c:pt idx="0">
                  <c:v>Complete vaccination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0:$P$10</c:f>
              <c:strCache>
                <c:ptCount val="15"/>
                <c:pt idx="0">
                  <c:v>Cough*</c:v>
                </c:pt>
                <c:pt idx="1">
                  <c:v>Sputum</c:v>
                </c:pt>
                <c:pt idx="2">
                  <c:v>Dry throat*</c:v>
                </c:pt>
                <c:pt idx="3">
                  <c:v>Itchy throat*</c:v>
                </c:pt>
                <c:pt idx="4">
                  <c:v>Sore throat</c:v>
                </c:pt>
                <c:pt idx="5">
                  <c:v>Chest thightness</c:v>
                </c:pt>
                <c:pt idx="6">
                  <c:v>Diarrhea</c:v>
                </c:pt>
                <c:pt idx="7">
                  <c:v>Abdominal distension*</c:v>
                </c:pt>
                <c:pt idx="8">
                  <c:v>Abdominal pain*</c:v>
                </c:pt>
                <c:pt idx="9">
                  <c:v>Nausea*</c:v>
                </c:pt>
                <c:pt idx="10">
                  <c:v>Fatigue</c:v>
                </c:pt>
                <c:pt idx="11">
                  <c:v>Headache</c:v>
                </c:pt>
                <c:pt idx="12">
                  <c:v>Muscle pain</c:v>
                </c:pt>
                <c:pt idx="13">
                  <c:v>Fever*</c:v>
                </c:pt>
                <c:pt idx="14">
                  <c:v>Chill*</c:v>
                </c:pt>
              </c:strCache>
            </c:strRef>
          </c:cat>
          <c:val>
            <c:numRef>
              <c:f>Sheet2!$B$12:$P$12</c:f>
              <c:numCache>
                <c:formatCode>###0.0%</c:formatCode>
                <c:ptCount val="15"/>
                <c:pt idx="0">
                  <c:v>0.837913553895411</c:v>
                </c:pt>
                <c:pt idx="1">
                  <c:v>0.64340981856990398</c:v>
                </c:pt>
                <c:pt idx="2">
                  <c:v>0.46411419423692635</c:v>
                </c:pt>
                <c:pt idx="3">
                  <c:v>0.34858591248665954</c:v>
                </c:pt>
                <c:pt idx="4">
                  <c:v>0.24573105656350053</c:v>
                </c:pt>
                <c:pt idx="5">
                  <c:v>0.1153948772678762</c:v>
                </c:pt>
                <c:pt idx="6">
                  <c:v>0.15701707577374599</c:v>
                </c:pt>
                <c:pt idx="7">
                  <c:v>0.10512273212379936</c:v>
                </c:pt>
                <c:pt idx="8">
                  <c:v>3.7486659551760941E-2</c:v>
                </c:pt>
                <c:pt idx="9">
                  <c:v>2.8948772678762006E-2</c:v>
                </c:pt>
                <c:pt idx="10">
                  <c:v>0.37046424759871932</c:v>
                </c:pt>
                <c:pt idx="11">
                  <c:v>0.16915688367129136</c:v>
                </c:pt>
                <c:pt idx="12">
                  <c:v>0.15314834578441835</c:v>
                </c:pt>
                <c:pt idx="13">
                  <c:v>3.5085378868729991E-2</c:v>
                </c:pt>
                <c:pt idx="14">
                  <c:v>3.215048025613660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DD-4D09-B16D-005501B651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0856864"/>
        <c:axId val="670857192"/>
      </c:barChart>
      <c:catAx>
        <c:axId val="670856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HK"/>
          </a:p>
        </c:txPr>
        <c:crossAx val="670857192"/>
        <c:crosses val="autoZero"/>
        <c:auto val="1"/>
        <c:lblAlgn val="ctr"/>
        <c:lblOffset val="100"/>
        <c:noMultiLvlLbl val="0"/>
      </c:catAx>
      <c:valAx>
        <c:axId val="6708571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HK"/>
          </a:p>
        </c:txPr>
        <c:crossAx val="6708568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HK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HK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omorbidity!$A$10</c:f>
              <c:strCache>
                <c:ptCount val="1"/>
                <c:pt idx="0">
                  <c:v>no comorbidity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comorbidity!$B$9:$P$9</c:f>
              <c:strCache>
                <c:ptCount val="15"/>
                <c:pt idx="0">
                  <c:v>Cough</c:v>
                </c:pt>
                <c:pt idx="1">
                  <c:v>Sputum*</c:v>
                </c:pt>
                <c:pt idx="2">
                  <c:v>dry throat</c:v>
                </c:pt>
                <c:pt idx="3">
                  <c:v>itchy throat*</c:v>
                </c:pt>
                <c:pt idx="4">
                  <c:v>sore throat*</c:v>
                </c:pt>
                <c:pt idx="5">
                  <c:v>chest thightness*</c:v>
                </c:pt>
                <c:pt idx="6">
                  <c:v>diarrhea</c:v>
                </c:pt>
                <c:pt idx="7">
                  <c:v>abdominal distension</c:v>
                </c:pt>
                <c:pt idx="8">
                  <c:v>abdominal pain</c:v>
                </c:pt>
                <c:pt idx="9">
                  <c:v>nausea</c:v>
                </c:pt>
                <c:pt idx="10">
                  <c:v>fatigue</c:v>
                </c:pt>
                <c:pt idx="11">
                  <c:v>headache*</c:v>
                </c:pt>
                <c:pt idx="12">
                  <c:v>muscle pain</c:v>
                </c:pt>
                <c:pt idx="13">
                  <c:v>fever</c:v>
                </c:pt>
                <c:pt idx="14">
                  <c:v>chill*</c:v>
                </c:pt>
              </c:strCache>
            </c:strRef>
          </c:cat>
          <c:val>
            <c:numRef>
              <c:f>comorbidity!$B$10:$P$10</c:f>
              <c:numCache>
                <c:formatCode>###0.0%</c:formatCode>
                <c:ptCount val="15"/>
                <c:pt idx="0">
                  <c:v>0.84198423127463851</c:v>
                </c:pt>
                <c:pt idx="1">
                  <c:v>0.63852387209811656</c:v>
                </c:pt>
                <c:pt idx="2">
                  <c:v>0.45751204555409541</c:v>
                </c:pt>
                <c:pt idx="3">
                  <c:v>0.33935611038107749</c:v>
                </c:pt>
                <c:pt idx="4">
                  <c:v>0.26631625054752517</c:v>
                </c:pt>
                <c:pt idx="5">
                  <c:v>0.11257117827420063</c:v>
                </c:pt>
                <c:pt idx="6">
                  <c:v>0.17279894875164259</c:v>
                </c:pt>
                <c:pt idx="7">
                  <c:v>0.12078405606657906</c:v>
                </c:pt>
                <c:pt idx="8">
                  <c:v>4.7744196233026719E-2</c:v>
                </c:pt>
                <c:pt idx="9">
                  <c:v>3.7450722733245727E-2</c:v>
                </c:pt>
                <c:pt idx="10">
                  <c:v>0.35775295663600526</c:v>
                </c:pt>
                <c:pt idx="11">
                  <c:v>0.17783618046430136</c:v>
                </c:pt>
                <c:pt idx="12">
                  <c:v>0.15002190100744633</c:v>
                </c:pt>
                <c:pt idx="13">
                  <c:v>4.4568550153307053E-2</c:v>
                </c:pt>
                <c:pt idx="14">
                  <c:v>4.577310556285588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B5-4C72-B709-AC8C3BC70BBD}"/>
            </c:ext>
          </c:extLst>
        </c:ser>
        <c:ser>
          <c:idx val="1"/>
          <c:order val="1"/>
          <c:tx>
            <c:strRef>
              <c:f>comorbidity!$A$11</c:f>
              <c:strCache>
                <c:ptCount val="1"/>
                <c:pt idx="0">
                  <c:v>1 or more comorbiditi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comorbidity!$B$9:$P$9</c:f>
              <c:strCache>
                <c:ptCount val="15"/>
                <c:pt idx="0">
                  <c:v>Cough</c:v>
                </c:pt>
                <c:pt idx="1">
                  <c:v>Sputum*</c:v>
                </c:pt>
                <c:pt idx="2">
                  <c:v>dry throat</c:v>
                </c:pt>
                <c:pt idx="3">
                  <c:v>itchy throat*</c:v>
                </c:pt>
                <c:pt idx="4">
                  <c:v>sore throat*</c:v>
                </c:pt>
                <c:pt idx="5">
                  <c:v>chest thightness*</c:v>
                </c:pt>
                <c:pt idx="6">
                  <c:v>diarrhea</c:v>
                </c:pt>
                <c:pt idx="7">
                  <c:v>abdominal distension</c:v>
                </c:pt>
                <c:pt idx="8">
                  <c:v>abdominal pain</c:v>
                </c:pt>
                <c:pt idx="9">
                  <c:v>nausea</c:v>
                </c:pt>
                <c:pt idx="10">
                  <c:v>fatigue</c:v>
                </c:pt>
                <c:pt idx="11">
                  <c:v>headache*</c:v>
                </c:pt>
                <c:pt idx="12">
                  <c:v>muscle pain</c:v>
                </c:pt>
                <c:pt idx="13">
                  <c:v>fever</c:v>
                </c:pt>
                <c:pt idx="14">
                  <c:v>chill*</c:v>
                </c:pt>
              </c:strCache>
            </c:strRef>
          </c:cat>
          <c:val>
            <c:numRef>
              <c:f>comorbidity!$B$11:$P$11</c:f>
              <c:numCache>
                <c:formatCode>###0.0%</c:formatCode>
                <c:ptCount val="15"/>
                <c:pt idx="0">
                  <c:v>0.85128561501042388</c:v>
                </c:pt>
                <c:pt idx="1">
                  <c:v>0.68346073662265472</c:v>
                </c:pt>
                <c:pt idx="2">
                  <c:v>0.45552466990965956</c:v>
                </c:pt>
                <c:pt idx="3">
                  <c:v>0.30298818624044477</c:v>
                </c:pt>
                <c:pt idx="4">
                  <c:v>0.19388464211257819</c:v>
                </c:pt>
                <c:pt idx="5">
                  <c:v>0.12995135510771369</c:v>
                </c:pt>
                <c:pt idx="6">
                  <c:v>0.17963863794301599</c:v>
                </c:pt>
                <c:pt idx="7">
                  <c:v>0.12161223071577484</c:v>
                </c:pt>
                <c:pt idx="8">
                  <c:v>4.6907574704656015E-2</c:v>
                </c:pt>
                <c:pt idx="9">
                  <c:v>3.7526059763724806E-2</c:v>
                </c:pt>
                <c:pt idx="10">
                  <c:v>0.38568450312717167</c:v>
                </c:pt>
                <c:pt idx="11">
                  <c:v>0.15392633773453787</c:v>
                </c:pt>
                <c:pt idx="12">
                  <c:v>0.14454482279360667</c:v>
                </c:pt>
                <c:pt idx="13">
                  <c:v>4.0305767894371097E-2</c:v>
                </c:pt>
                <c:pt idx="14">
                  <c:v>3.613620569840166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B5-4C72-B709-AC8C3BC70B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484560"/>
        <c:axId val="657478328"/>
      </c:barChart>
      <c:catAx>
        <c:axId val="657484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HK"/>
          </a:p>
        </c:txPr>
        <c:crossAx val="657478328"/>
        <c:crosses val="autoZero"/>
        <c:auto val="1"/>
        <c:lblAlgn val="ctr"/>
        <c:lblOffset val="100"/>
        <c:noMultiLvlLbl val="0"/>
      </c:catAx>
      <c:valAx>
        <c:axId val="657478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HK"/>
          </a:p>
        </c:txPr>
        <c:crossAx val="6574845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7759182189400999"/>
          <c:y val="0.89689932109434056"/>
          <c:w val="0.48959987901004515"/>
          <c:h val="7.605801751030069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HK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HK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12003A-0F01-49C8-8441-745D8B5495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05641D-CE6E-4225-8981-6E5F03C4FC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9443C1-306C-4243-B185-6A0978982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F68E82-D3B4-43F1-9FA6-2BB278FCA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966961-9973-4093-AECA-59BFDEB59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800358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91C757-A77A-4B51-86DA-1CCB732530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C2FC1C8-C9DA-42A3-AF7A-7EDC1E0D75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702F70-4263-407C-8506-85CE1B29D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DA158A-FBA1-4896-ABD5-708EC5257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29DA4E-221A-4084-9F15-EDF7CC1674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902002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DD42820-53AB-4917-B4BC-6F9A8CCA26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C07E29D-9B7C-496B-9B19-0FAD41BF1D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8868A9-81F5-4C6A-AE50-D0BF12E18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368A0E5-ABBA-4CB6-B169-1F8539CF9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296371-DA91-41A0-B885-1EFD89C37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102547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9C535D-C719-4CF6-B48D-27DE8293F2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A1F8053-B86D-4816-B4FF-0AFDAC3414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A27D0A-AA98-42FF-8990-FA53CDA30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6F74BE-DFA8-4776-9022-A1AE25BD2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319888-61A5-4F74-945D-03DF2BC8E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248512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A6A931-C204-4B7E-A4A1-4E80AE49AA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9CC244E-4206-4D37-BC2C-6FA9EA53F0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D421DB-F74F-4568-AF8B-9F124A555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0BCDC5-2F21-464D-8824-3E909E04B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E3BFA4-3743-4F29-B67F-0ED8A81E3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323576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6FA668-0B3D-47D1-8614-DEEA7E1BEE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9EC376-520B-4AC9-86C1-D079B83A6B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zh-HK" alt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E3B41A8-5056-4F7A-9215-521073F262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zh-HK" alt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F7E1004-9130-4EF0-86E2-F28476F67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1C00E1C-A3E1-4CF7-BC83-FCC2C2FE2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F5FEACA-551F-4807-B372-6685291048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91275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9B18BA-771B-4B3B-A972-F5016937F3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6597899-1A6B-4F9F-B621-43109096D8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0FD4F8F-B0DD-4832-A502-EE1E23F170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zh-HK" alt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606CCFA-F7D2-4622-83A2-B5E7026A1A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F2B8154-DDA0-4098-8982-61EC86061F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zh-HK" alt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A2E3188-836E-4F93-B5B5-E6852D4A0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37925D8-1BFB-40B7-9587-466F4264A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C343686-9C00-4154-A5F3-C0EE1F8FB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911542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5243A9-EBAC-4BB1-887D-6E175C2D09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403F2DE-B41F-4CD5-82C2-0A8F00867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B851371-D857-4167-897E-ED8BB24E2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34FFC5E-2D2A-4176-9D9B-A14A591EF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344330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5398646-16E3-4DC3-B091-EF8EC4E47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C381749-3938-4EAD-990D-982159E0A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93241A4-A4F2-4D9C-AA90-4263C5ED4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280095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C3574D-5FFC-442B-9E44-CDF985F44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2F37B6-4B94-4C7C-A75B-FDD77C9817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zh-HK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BF39A05-BC8A-406E-A818-076EE59516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F0F768-E419-49D6-835B-081190439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D4F8ACC-566B-470D-A60D-5EE53410E2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CEDBBC4-E3E4-42B1-8D44-291D258E9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206972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05562E-E4D5-4250-9BDC-4740C26193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23E712A-DA63-40D2-B074-735C4069DA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HK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965DDE5-E6D3-44E1-B67D-045BEC309C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F127371-F943-4109-8559-8DCB78452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8B85BF5-B088-48C1-ACEC-BB2CAD30D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109C90A-5A0C-4EE1-A1BF-E3F0D6FDF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75250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4073D52-DC24-41EF-95D4-DBD44C1A03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87807B-EAA2-431D-B50C-C30AD3EB93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8837A3-0A2D-4BBC-ADB6-6EFF904D14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026371-ABC7-41B9-8508-7F5077337617}" type="datetimeFigureOut">
              <a:rPr lang="zh-HK" altLang="en-US" smtClean="0"/>
              <a:t>21/12/2022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D2B508D-6410-4399-9A68-C0E0AE173F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9B825B-69F7-4A19-9A3A-A01E3C9635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E76A45-9853-41BB-A040-98B9F7009A3F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065111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H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C15EB68D-1BBE-E10A-6745-AA9E89F8901C}"/>
              </a:ext>
            </a:extLst>
          </p:cNvPr>
          <p:cNvGrpSpPr/>
          <p:nvPr/>
        </p:nvGrpSpPr>
        <p:grpSpPr>
          <a:xfrm>
            <a:off x="493445" y="0"/>
            <a:ext cx="10574605" cy="5724525"/>
            <a:chOff x="-196481" y="-2760663"/>
            <a:chExt cx="12386210" cy="6870147"/>
          </a:xfrm>
        </p:grpSpPr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1CD00588-C48A-B234-8909-8350FFC4E88B}"/>
                </a:ext>
              </a:extLst>
            </p:cNvPr>
            <p:cNvSpPr txBox="1"/>
            <p:nvPr/>
          </p:nvSpPr>
          <p:spPr>
            <a:xfrm>
              <a:off x="-83913" y="-2699247"/>
              <a:ext cx="4665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SG"/>
                <a:t>A</a:t>
              </a:r>
              <a:endParaRPr lang="zh-SG" altLang="en-US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540716D8-5C63-ED3B-5F68-710D1F0305FE}"/>
                </a:ext>
              </a:extLst>
            </p:cNvPr>
            <p:cNvSpPr txBox="1"/>
            <p:nvPr/>
          </p:nvSpPr>
          <p:spPr>
            <a:xfrm>
              <a:off x="-196481" y="1316901"/>
              <a:ext cx="4665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SG" dirty="0"/>
                <a:t>C</a:t>
              </a:r>
              <a:endParaRPr lang="zh-SG" altLang="en-US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F86F42DE-1968-DB31-BCC4-39EE89721B3A}"/>
                </a:ext>
              </a:extLst>
            </p:cNvPr>
            <p:cNvSpPr txBox="1"/>
            <p:nvPr/>
          </p:nvSpPr>
          <p:spPr>
            <a:xfrm>
              <a:off x="6378457" y="-2760663"/>
              <a:ext cx="4665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SG" dirty="0"/>
                <a:t>B</a:t>
              </a:r>
              <a:endParaRPr lang="zh-SG" altLang="en-US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CE75C1B2-396A-43BF-A334-FB2D1D4E0468}"/>
                </a:ext>
              </a:extLst>
            </p:cNvPr>
            <p:cNvSpPr txBox="1"/>
            <p:nvPr/>
          </p:nvSpPr>
          <p:spPr>
            <a:xfrm>
              <a:off x="6378457" y="1262913"/>
              <a:ext cx="4665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SG" dirty="0"/>
                <a:t>D</a:t>
              </a:r>
              <a:endParaRPr lang="zh-SG" altLang="en-US" dirty="0"/>
            </a:p>
          </p:txBody>
        </p:sp>
        <p:graphicFrame>
          <p:nvGraphicFramePr>
            <p:cNvPr id="22" name="图表 21">
              <a:extLst>
                <a:ext uri="{FF2B5EF4-FFF2-40B4-BE49-F238E27FC236}">
                  <a16:creationId xmlns:a16="http://schemas.microsoft.com/office/drawing/2014/main" id="{5882B5EE-213E-42EB-A859-F0C90FEA509C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70051" y="-2668074"/>
            <a:ext cx="5344740" cy="33713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25" name="图表 24">
              <a:extLst>
                <a:ext uri="{FF2B5EF4-FFF2-40B4-BE49-F238E27FC236}">
                  <a16:creationId xmlns:a16="http://schemas.microsoft.com/office/drawing/2014/main" id="{ACBB3A39-CDBE-46E7-9D24-E2E416071B88}"/>
                </a:ext>
              </a:extLst>
            </p:cNvPr>
            <p:cNvGraphicFramePr/>
            <p:nvPr/>
          </p:nvGraphicFramePr>
          <p:xfrm>
            <a:off x="6844989" y="-2514581"/>
            <a:ext cx="5344740" cy="28177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0" name="图表 19">
              <a:extLst>
                <a:ext uri="{FF2B5EF4-FFF2-40B4-BE49-F238E27FC236}">
                  <a16:creationId xmlns:a16="http://schemas.microsoft.com/office/drawing/2014/main" id="{2CE178BD-53DB-3F10-107B-CF6BD2B29BA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89689" y="1291714"/>
            <a:ext cx="5104555" cy="28177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7" name="图表 26">
              <a:extLst>
                <a:ext uri="{FF2B5EF4-FFF2-40B4-BE49-F238E27FC236}">
                  <a16:creationId xmlns:a16="http://schemas.microsoft.com/office/drawing/2014/main" id="{1F87C08C-159D-A473-F66B-453FADEF684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965081" y="1262913"/>
            <a:ext cx="5104556" cy="28177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3" name="矩形 2">
            <a:extLst>
              <a:ext uri="{FF2B5EF4-FFF2-40B4-BE49-F238E27FC236}">
                <a16:creationId xmlns:a16="http://schemas.microsoft.com/office/drawing/2014/main" id="{534E7752-799D-42FA-BDBF-8100F640B1CE}"/>
              </a:ext>
            </a:extLst>
          </p:cNvPr>
          <p:cNvSpPr/>
          <p:nvPr/>
        </p:nvSpPr>
        <p:spPr>
          <a:xfrm>
            <a:off x="0" y="6017545"/>
            <a:ext cx="10544824" cy="7221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GB" altLang="zh-HK" sz="1200" b="1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Supplementary Figure 1.</a:t>
            </a:r>
            <a:r>
              <a:rPr lang="en-GB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GB" altLang="zh-HK" sz="1200" b="1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Symptom profiles by different risk factors.</a:t>
            </a:r>
            <a:r>
              <a:rPr lang="en-GB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 (A) Different age groups. (B) Male and female population. (C) Patients with incomplete vaccination and complete vaccination status (D) Patients with or without at least 1 comorbidity. The prevalence of symptoms is represented as percentage. *Significant difference (p&lt;0.05).</a:t>
            </a:r>
            <a:endParaRPr lang="zh-TW" altLang="zh-HK" sz="1200" dirty="0">
              <a:solidFill>
                <a:srgbClr val="000000"/>
              </a:solidFill>
              <a:latin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9435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6928E71B-24A4-4C33-9AB7-9FB63F09EDBE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3869" y="193040"/>
            <a:ext cx="8009256" cy="394081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0AD7A1A1-F1D9-4721-9A3A-35EF0DE9A759}"/>
              </a:ext>
            </a:extLst>
          </p:cNvPr>
          <p:cNvSpPr/>
          <p:nvPr/>
        </p:nvSpPr>
        <p:spPr>
          <a:xfrm>
            <a:off x="571500" y="5485606"/>
            <a:ext cx="11049000" cy="7221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GB" altLang="zh-HK" sz="1200" b="1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Supplementary Figure 2.</a:t>
            </a:r>
            <a:r>
              <a:rPr lang="en-GB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GB" altLang="zh-HK" sz="1200" b="1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Linear regression matrix for association between symptoms and risk factors</a:t>
            </a:r>
            <a:r>
              <a:rPr lang="en-GB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 (age, gender, days after being diagnosed, vaccination status and underlying chronic disease). </a:t>
            </a:r>
            <a:r>
              <a:rPr lang="zh-CN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GB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 values are shown in different colours in the graph. The colour scale on the right shows the colour partitioning of the different </a:t>
            </a:r>
            <a:r>
              <a:rPr lang="zh-CN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GB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 values. </a:t>
            </a:r>
            <a:r>
              <a:rPr lang="zh-CN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GB" altLang="zh-HK" sz="12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</a:rPr>
              <a:t> values which are statistically significant (p&lt;0.05) are coloured, not significant value are marked as NS.</a:t>
            </a:r>
            <a:endParaRPr lang="zh-TW" altLang="zh-HK" sz="1200" dirty="0">
              <a:solidFill>
                <a:srgbClr val="000000"/>
              </a:solidFill>
              <a:latin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7195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F40D5219AFCF3488A0BA26AD660799B" ma:contentTypeVersion="14" ma:contentTypeDescription="Create a new document." ma:contentTypeScope="" ma:versionID="c87e618acb3e4d05bf67bef139c6d8f1">
  <xsd:schema xmlns:xsd="http://www.w3.org/2001/XMLSchema" xmlns:xs="http://www.w3.org/2001/XMLSchema" xmlns:p="http://schemas.microsoft.com/office/2006/metadata/properties" xmlns:ns3="88d4f759-5172-4f1e-90b9-eddc1aea6696" xmlns:ns4="8033c5c9-907f-499e-aa28-ef4da1f3aaf4" targetNamespace="http://schemas.microsoft.com/office/2006/metadata/properties" ma:root="true" ma:fieldsID="b60a060f8ffc38f4c8126e0c3286c10e" ns3:_="" ns4:_="">
    <xsd:import namespace="88d4f759-5172-4f1e-90b9-eddc1aea6696"/>
    <xsd:import namespace="8033c5c9-907f-499e-aa28-ef4da1f3aaf4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Location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8d4f759-5172-4f1e-90b9-eddc1aea6696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033c5c9-907f-499e-aa28-ef4da1f3aaf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21AFCAA3-118E-4AA5-8FA4-6AAD131846A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8d4f759-5172-4f1e-90b9-eddc1aea6696"/>
    <ds:schemaRef ds:uri="8033c5c9-907f-499e-aa28-ef4da1f3aaf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E990D7F-B5FF-4D20-A5C0-DF7830D81FF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802C627-81EB-4B44-9796-1082DB323E00}">
  <ds:schemaRefs>
    <ds:schemaRef ds:uri="http://www.w3.org/XML/1998/namespace"/>
    <ds:schemaRef ds:uri="http://purl.org/dc/terms/"/>
    <ds:schemaRef ds:uri="http://purl.org/dc/elements/1.1/"/>
    <ds:schemaRef ds:uri="8033c5c9-907f-499e-aa28-ef4da1f3aaf4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88d4f759-5172-4f1e-90b9-eddc1aea6696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50</Words>
  <Application>Microsoft Office PowerPoint</Application>
  <PresentationFormat>宽屏</PresentationFormat>
  <Paragraphs>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2" baseType="lpstr">
      <vt:lpstr>等线</vt:lpstr>
      <vt:lpstr>等线</vt:lpstr>
      <vt:lpstr>等线 Light</vt:lpstr>
      <vt:lpstr>新細明體</vt:lpstr>
      <vt:lpstr>Arial</vt:lpstr>
      <vt:lpstr>Calibri</vt:lpstr>
      <vt:lpstr>Calibri Light</vt:lpstr>
      <vt:lpstr>Courier New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UO Jingyuan</dc:creator>
  <cp:lastModifiedBy>LUO Jingyuan</cp:lastModifiedBy>
  <cp:revision>3</cp:revision>
  <dcterms:created xsi:type="dcterms:W3CDTF">2022-09-05T01:15:47Z</dcterms:created>
  <dcterms:modified xsi:type="dcterms:W3CDTF">2022-12-21T09:32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F40D5219AFCF3488A0BA26AD660799B</vt:lpwstr>
  </property>
</Properties>
</file>